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05" autoAdjust="0"/>
    <p:restoredTop sz="94660"/>
  </p:normalViewPr>
  <p:slideViewPr>
    <p:cSldViewPr snapToGrid="0">
      <p:cViewPr varScale="1">
        <p:scale>
          <a:sx n="62" d="100"/>
          <a:sy n="62" d="100"/>
        </p:scale>
        <p:origin x="6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8577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9732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32965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7432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851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9628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974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3277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0242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6042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9184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44B164-8CC5-4B24-A932-A484BAA8A99A}" type="datetimeFigureOut">
              <a:rPr lang="en-GB" smtClean="0"/>
              <a:t>06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FB6A37-F8C0-4F20-B93F-1A6D188EEF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5581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0.emf"/><Relationship Id="rId4" Type="http://schemas.openxmlformats.org/officeDocument/2006/relationships/image" Target="../media/image39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0.emf"/><Relationship Id="rId4" Type="http://schemas.openxmlformats.org/officeDocument/2006/relationships/image" Target="../media/image49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emf"/><Relationship Id="rId7" Type="http://schemas.openxmlformats.org/officeDocument/2006/relationships/image" Target="../media/image5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54.emf"/><Relationship Id="rId4" Type="http://schemas.openxmlformats.org/officeDocument/2006/relationships/image" Target="../media/image53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emf"/><Relationship Id="rId4" Type="http://schemas.openxmlformats.org/officeDocument/2006/relationships/image" Target="../media/image3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59"/>
          <a:stretch/>
        </p:blipFill>
        <p:spPr bwMode="auto">
          <a:xfrm>
            <a:off x="696384" y="952500"/>
            <a:ext cx="5118100" cy="24828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99"/>
          <a:stretch/>
        </p:blipFill>
        <p:spPr bwMode="auto">
          <a:xfrm>
            <a:off x="696384" y="3905250"/>
            <a:ext cx="5118100" cy="2476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09747" y="787400"/>
            <a:ext cx="3849687" cy="2755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1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41497" y="3703638"/>
            <a:ext cx="4149725" cy="27638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Rectangle 12"/>
          <p:cNvSpPr/>
          <p:nvPr/>
        </p:nvSpPr>
        <p:spPr>
          <a:xfrm>
            <a:off x="742421" y="871538"/>
            <a:ext cx="9642476" cy="268605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14" name="Rectangle 13"/>
          <p:cNvSpPr/>
          <p:nvPr/>
        </p:nvSpPr>
        <p:spPr>
          <a:xfrm>
            <a:off x="696384" y="3678238"/>
            <a:ext cx="9642475" cy="268446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17" name="TextBox 16"/>
          <p:cNvSpPr txBox="1"/>
          <p:nvPr/>
        </p:nvSpPr>
        <p:spPr>
          <a:xfrm>
            <a:off x="742421" y="201394"/>
            <a:ext cx="97066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Top chromatograms are taken from a patient CSF sample bottom chromatograms are CSF spiked peptides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583295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99"/>
          <a:stretch/>
        </p:blipFill>
        <p:spPr bwMode="auto">
          <a:xfrm>
            <a:off x="1260928" y="698500"/>
            <a:ext cx="5118100" cy="2565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55"/>
          <a:stretch/>
        </p:blipFill>
        <p:spPr bwMode="auto">
          <a:xfrm>
            <a:off x="1260928" y="3587750"/>
            <a:ext cx="5118100" cy="2533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5378" y="3287104"/>
            <a:ext cx="3822700" cy="23262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5658" y="660400"/>
            <a:ext cx="3773070" cy="2362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60928" y="596900"/>
            <a:ext cx="9670143" cy="26543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60928" y="3340100"/>
            <a:ext cx="9670143" cy="29210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274495360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0066" y="259829"/>
            <a:ext cx="4581726" cy="29994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266" y="316980"/>
            <a:ext cx="5486400" cy="3822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692266" y="266180"/>
            <a:ext cx="10109200" cy="39878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213694326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77"/>
          <a:stretch/>
        </p:blipFill>
        <p:spPr bwMode="auto">
          <a:xfrm>
            <a:off x="1428296" y="721979"/>
            <a:ext cx="5118100" cy="2546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99"/>
          <a:stretch/>
        </p:blipFill>
        <p:spPr bwMode="auto">
          <a:xfrm>
            <a:off x="1447346" y="3662029"/>
            <a:ext cx="5118100" cy="2559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30794" y="535321"/>
            <a:ext cx="4309802" cy="27774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4"/>
          <p:cNvSpPr/>
          <p:nvPr/>
        </p:nvSpPr>
        <p:spPr>
          <a:xfrm>
            <a:off x="1251403" y="568672"/>
            <a:ext cx="9670143" cy="28212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82946" y="3344529"/>
            <a:ext cx="3708400" cy="2978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768882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20"/>
          <a:stretch/>
        </p:blipFill>
        <p:spPr bwMode="auto">
          <a:xfrm>
            <a:off x="1323521" y="702827"/>
            <a:ext cx="5118100" cy="257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2"/>
          <a:stretch/>
        </p:blipFill>
        <p:spPr bwMode="auto">
          <a:xfrm>
            <a:off x="1431471" y="3700027"/>
            <a:ext cx="5118100" cy="2597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11521" y="3567640"/>
            <a:ext cx="3651250" cy="28323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8980" y="440172"/>
            <a:ext cx="4222348" cy="32444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73628" y="537727"/>
            <a:ext cx="9670143" cy="297179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48228" y="3534928"/>
            <a:ext cx="9670143" cy="28829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49908552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81"/>
          <a:stretch/>
        </p:blipFill>
        <p:spPr bwMode="auto">
          <a:xfrm>
            <a:off x="1176116" y="482242"/>
            <a:ext cx="5118100" cy="2584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31165" y="228242"/>
            <a:ext cx="3373573" cy="2889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1024623" y="253643"/>
            <a:ext cx="9670143" cy="28829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24623" y="3805047"/>
            <a:ext cx="5974045" cy="2836373"/>
          </a:xfrm>
          <a:prstGeom prst="rect">
            <a:avLst/>
          </a:prstGeom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4609898"/>
              </p:ext>
            </p:extLst>
          </p:nvPr>
        </p:nvGraphicFramePr>
        <p:xfrm>
          <a:off x="7083148" y="3483264"/>
          <a:ext cx="4393085" cy="3479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Project" r:id="rId6" imgW="3636000" imgH="2880000" progId="Prism5.Document">
                  <p:embed/>
                </p:oleObj>
              </mc:Choice>
              <mc:Fallback>
                <p:oleObj name="Prism Project" r:id="rId6" imgW="3636000" imgH="288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083148" y="3483264"/>
                        <a:ext cx="4393085" cy="3479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6"/>
          <p:cNvSpPr/>
          <p:nvPr/>
        </p:nvSpPr>
        <p:spPr>
          <a:xfrm>
            <a:off x="940143" y="3483264"/>
            <a:ext cx="10340882" cy="337473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8" name="TextBox 7"/>
          <p:cNvSpPr txBox="1"/>
          <p:nvPr/>
        </p:nvSpPr>
        <p:spPr>
          <a:xfrm>
            <a:off x="10252977" y="4438129"/>
            <a:ext cx="883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r</a:t>
            </a:r>
            <a:r>
              <a:rPr lang="en-GB" baseline="30000" dirty="0" smtClean="0"/>
              <a:t>2</a:t>
            </a:r>
            <a:r>
              <a:rPr lang="en-GB" dirty="0" smtClean="0"/>
              <a:t>=0.9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7766551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0319" y="770254"/>
            <a:ext cx="4578094" cy="21736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79223" y="488722"/>
            <a:ext cx="3714469" cy="29216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9955658" y="770254"/>
            <a:ext cx="8835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r</a:t>
            </a:r>
            <a:r>
              <a:rPr lang="en-GB" baseline="30000" dirty="0" smtClean="0"/>
              <a:t>2</a:t>
            </a:r>
            <a:r>
              <a:rPr lang="en-GB" dirty="0" smtClean="0"/>
              <a:t>=0.9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61357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2"/>
          <a:stretch/>
        </p:blipFill>
        <p:spPr bwMode="auto">
          <a:xfrm>
            <a:off x="1263611" y="677863"/>
            <a:ext cx="5118100" cy="2590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81"/>
          <a:stretch/>
        </p:blipFill>
        <p:spPr bwMode="auto">
          <a:xfrm>
            <a:off x="1295361" y="3529013"/>
            <a:ext cx="5118100" cy="2584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29461" y="3325813"/>
            <a:ext cx="3048000" cy="2851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8799" y="458788"/>
            <a:ext cx="3484562" cy="28924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7"/>
          <p:cNvSpPr/>
          <p:nvPr/>
        </p:nvSpPr>
        <p:spPr>
          <a:xfrm>
            <a:off x="1150899" y="523876"/>
            <a:ext cx="9669462" cy="282257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9" name="Rectangle 8"/>
          <p:cNvSpPr/>
          <p:nvPr/>
        </p:nvSpPr>
        <p:spPr>
          <a:xfrm>
            <a:off x="1163599" y="3349626"/>
            <a:ext cx="9669462" cy="282257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522023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77"/>
          <a:stretch/>
        </p:blipFill>
        <p:spPr bwMode="auto">
          <a:xfrm>
            <a:off x="1329871" y="744310"/>
            <a:ext cx="5118100" cy="2546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38"/>
          <a:stretch/>
        </p:blipFill>
        <p:spPr bwMode="auto">
          <a:xfrm>
            <a:off x="1387021" y="3595460"/>
            <a:ext cx="5118100" cy="2552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1787" y="3538310"/>
            <a:ext cx="3835933" cy="279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67589" y="617310"/>
            <a:ext cx="3885632" cy="2451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60021" y="525689"/>
            <a:ext cx="9671958" cy="28212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60021" y="525689"/>
            <a:ext cx="9670143" cy="282121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8" name="Rectangle 7"/>
          <p:cNvSpPr/>
          <p:nvPr/>
        </p:nvSpPr>
        <p:spPr>
          <a:xfrm>
            <a:off x="1260021" y="3535589"/>
            <a:ext cx="9670143" cy="27522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13552928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99"/>
          <a:stretch/>
        </p:blipFill>
        <p:spPr bwMode="auto">
          <a:xfrm>
            <a:off x="1371600" y="432712"/>
            <a:ext cx="5118100" cy="25590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20"/>
          <a:stretch/>
        </p:blipFill>
        <p:spPr bwMode="auto">
          <a:xfrm>
            <a:off x="1250950" y="4147462"/>
            <a:ext cx="5118100" cy="257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33522" y="3969662"/>
            <a:ext cx="3923327" cy="2501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3072" y="94337"/>
            <a:ext cx="4297978" cy="2732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50950" y="277591"/>
            <a:ext cx="9670143" cy="29046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63650" y="3858991"/>
            <a:ext cx="9670143" cy="29046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41109541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81"/>
          <a:stretch/>
        </p:blipFill>
        <p:spPr bwMode="auto">
          <a:xfrm>
            <a:off x="1260928" y="860878"/>
            <a:ext cx="5118100" cy="2584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59"/>
          <a:stretch/>
        </p:blipFill>
        <p:spPr bwMode="auto">
          <a:xfrm>
            <a:off x="1260928" y="3731078"/>
            <a:ext cx="5118100" cy="25717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03940" y="3692978"/>
            <a:ext cx="3575538" cy="2679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38251" y="402772"/>
            <a:ext cx="4523875" cy="31867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60928" y="629557"/>
            <a:ext cx="9670143" cy="29046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60928" y="3550557"/>
            <a:ext cx="9670143" cy="29046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6602717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20"/>
          <a:stretch/>
        </p:blipFill>
        <p:spPr bwMode="auto">
          <a:xfrm>
            <a:off x="1260928" y="612775"/>
            <a:ext cx="5118100" cy="257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20"/>
          <a:stretch/>
        </p:blipFill>
        <p:spPr bwMode="auto">
          <a:xfrm>
            <a:off x="1260928" y="3470275"/>
            <a:ext cx="5118100" cy="257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4976" y="504825"/>
            <a:ext cx="3754702" cy="27305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9178" y="3090660"/>
            <a:ext cx="4057650" cy="2991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60928" y="527504"/>
            <a:ext cx="9670143" cy="29046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60928" y="3448504"/>
            <a:ext cx="9670143" cy="29046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37418985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20"/>
          <a:stretch/>
        </p:blipFill>
        <p:spPr bwMode="auto">
          <a:xfrm>
            <a:off x="1250950" y="736600"/>
            <a:ext cx="5118100" cy="257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81"/>
          <a:stretch/>
        </p:blipFill>
        <p:spPr bwMode="auto">
          <a:xfrm>
            <a:off x="1250950" y="3587750"/>
            <a:ext cx="5118100" cy="2584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90716" y="3270250"/>
            <a:ext cx="4250334" cy="3181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63978" y="406400"/>
            <a:ext cx="4100822" cy="3105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50950" y="558800"/>
            <a:ext cx="9670143" cy="285749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50950" y="3479800"/>
            <a:ext cx="9670143" cy="285749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34502223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77"/>
          <a:stretch/>
        </p:blipFill>
        <p:spPr bwMode="auto">
          <a:xfrm>
            <a:off x="1206500" y="704850"/>
            <a:ext cx="5118100" cy="2546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59"/>
          <a:stretch/>
        </p:blipFill>
        <p:spPr bwMode="auto">
          <a:xfrm>
            <a:off x="1206500" y="3587750"/>
            <a:ext cx="5118100" cy="2565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2184" y="584200"/>
            <a:ext cx="4223315" cy="2641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57630" y="3112111"/>
            <a:ext cx="3516620" cy="31299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19200" y="660401"/>
            <a:ext cx="9670143" cy="25654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06500" y="3200400"/>
            <a:ext cx="9670143" cy="307339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29455225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38"/>
          <a:stretch/>
        </p:blipFill>
        <p:spPr bwMode="auto">
          <a:xfrm>
            <a:off x="1260928" y="711200"/>
            <a:ext cx="5118100" cy="2552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220"/>
          <a:stretch/>
        </p:blipFill>
        <p:spPr bwMode="auto">
          <a:xfrm>
            <a:off x="1260928" y="3543300"/>
            <a:ext cx="5118100" cy="2578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94486" y="501650"/>
            <a:ext cx="4251741" cy="2781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85378" y="3125832"/>
            <a:ext cx="3987799" cy="32305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260928" y="622301"/>
            <a:ext cx="9670143" cy="26543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  <p:sp>
        <p:nvSpPr>
          <p:cNvPr id="7" name="Rectangle 6"/>
          <p:cNvSpPr/>
          <p:nvPr/>
        </p:nvSpPr>
        <p:spPr>
          <a:xfrm>
            <a:off x="1260928" y="3314700"/>
            <a:ext cx="9670143" cy="293369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endParaRPr lang="en-GB" sz="1100"/>
          </a:p>
        </p:txBody>
      </p:sp>
    </p:spTree>
    <p:extLst>
      <p:ext uri="{BB962C8B-B14F-4D97-AF65-F5344CB8AC3E}">
        <p14:creationId xmlns:p14="http://schemas.microsoft.com/office/powerpoint/2010/main" val="2680515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7</Words>
  <Application>Microsoft Office PowerPoint</Application>
  <PresentationFormat>Widescreen</PresentationFormat>
  <Paragraphs>3</Paragraphs>
  <Slides>1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GraphPad Prism 5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C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dy Heywood</dc:creator>
  <cp:lastModifiedBy>Wendy Heywood</cp:lastModifiedBy>
  <cp:revision>5</cp:revision>
  <dcterms:created xsi:type="dcterms:W3CDTF">2015-06-07T13:17:02Z</dcterms:created>
  <dcterms:modified xsi:type="dcterms:W3CDTF">2015-09-06T16:48:29Z</dcterms:modified>
</cp:coreProperties>
</file>